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4176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7364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8072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3231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15612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831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9453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1330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317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4024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9027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7EECD9-CD97-40E0-A30B-A8F6123EF992}" type="datetimeFigureOut">
              <a:rPr lang="zh-CN" altLang="en-US" smtClean="0"/>
              <a:t>2018/1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F6A231-74F8-4C78-85A1-3634CFD2E5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0405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7" Type="http://schemas.openxmlformats.org/officeDocument/2006/relationships/image" Target="../media/image21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jpeg"/><Relationship Id="rId5" Type="http://schemas.openxmlformats.org/officeDocument/2006/relationships/image" Target="../media/image19.jpeg"/><Relationship Id="rId4" Type="http://schemas.openxmlformats.org/officeDocument/2006/relationships/image" Target="../media/image18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508" y="481366"/>
            <a:ext cx="3240024" cy="2429256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9718" y="554943"/>
            <a:ext cx="3240024" cy="242925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3988" y="554943"/>
            <a:ext cx="3240024" cy="2429256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3875532" y="4245253"/>
            <a:ext cx="43795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Source Data-Figure 6d-</a:t>
            </a:r>
            <a:r>
              <a:rPr lang="zh-CN" altLang="en-US" dirty="0" smtClean="0"/>
              <a:t>KI67-NGs</a:t>
            </a:r>
            <a:r>
              <a:rPr lang="en-US" altLang="zh-CN" dirty="0" smtClean="0"/>
              <a:t>, PBS, 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0940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382" y="748354"/>
            <a:ext cx="3240024" cy="2429256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7645" y="748354"/>
            <a:ext cx="3240024" cy="242925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1736" y="748354"/>
            <a:ext cx="3240024" cy="2429256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3875532" y="4245253"/>
            <a:ext cx="48621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Source Data-Figure 6d-tumor HE</a:t>
            </a:r>
            <a:r>
              <a:rPr lang="zh-CN" altLang="en-US" dirty="0" smtClean="0"/>
              <a:t>-NGs</a:t>
            </a:r>
            <a:r>
              <a:rPr lang="en-US" altLang="zh-CN" dirty="0" smtClean="0"/>
              <a:t>, PBS, 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325560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000" y="365125"/>
            <a:ext cx="3840000" cy="2880000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2874" y="365125"/>
            <a:ext cx="3840000" cy="28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9749" y="365125"/>
            <a:ext cx="3840000" cy="2880000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3875532" y="4245253"/>
            <a:ext cx="44565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Source Data-Figure 6d-tunel</a:t>
            </a:r>
            <a:r>
              <a:rPr lang="zh-CN" altLang="en-US" dirty="0" smtClean="0"/>
              <a:t>-NGs</a:t>
            </a:r>
            <a:r>
              <a:rPr lang="en-US" altLang="zh-CN" dirty="0" smtClean="0"/>
              <a:t>, PBS, 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177947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200" y="365125"/>
            <a:ext cx="3240024" cy="2429256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4731" y="365125"/>
            <a:ext cx="3240024" cy="242925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3776" y="365125"/>
            <a:ext cx="3240024" cy="2429256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200" y="3581617"/>
            <a:ext cx="3240024" cy="2429256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4731" y="3581617"/>
            <a:ext cx="3240024" cy="2429256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3776" y="3581617"/>
            <a:ext cx="3240024" cy="242925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523504" y="2895424"/>
            <a:ext cx="45190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Source Data-Figure 6e-heart</a:t>
            </a:r>
            <a:r>
              <a:rPr lang="zh-CN" altLang="en-US" dirty="0" smtClean="0"/>
              <a:t>-NGs</a:t>
            </a:r>
            <a:r>
              <a:rPr lang="en-US" altLang="zh-CN" dirty="0" smtClean="0"/>
              <a:t>, PBS, SCNGs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3523504" y="6143068"/>
            <a:ext cx="458010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Source Data-Figure 6e-kidney</a:t>
            </a:r>
            <a:r>
              <a:rPr lang="zh-CN" altLang="en-US" dirty="0" smtClean="0"/>
              <a:t>-NGs</a:t>
            </a:r>
            <a:r>
              <a:rPr lang="en-US" altLang="zh-CN" dirty="0" smtClean="0"/>
              <a:t>, PBS, 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552994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868" y="365125"/>
            <a:ext cx="3240024" cy="2429256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9194" y="365125"/>
            <a:ext cx="3240024" cy="242925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0188" y="365125"/>
            <a:ext cx="3240024" cy="2429256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868" y="3337778"/>
            <a:ext cx="3240024" cy="2429256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4028" y="3337778"/>
            <a:ext cx="3240024" cy="2429256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0188" y="3337778"/>
            <a:ext cx="3240024" cy="2429256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523504" y="2895424"/>
            <a:ext cx="43645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Source Data-Figure 6e-liver</a:t>
            </a:r>
            <a:r>
              <a:rPr lang="zh-CN" altLang="en-US" dirty="0" smtClean="0"/>
              <a:t>-NGs</a:t>
            </a:r>
            <a:r>
              <a:rPr lang="en-US" altLang="zh-CN" dirty="0" smtClean="0"/>
              <a:t>, PBS, SCNGs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3523504" y="5941099"/>
            <a:ext cx="43667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Source Data-Figure 6e-lung</a:t>
            </a:r>
            <a:r>
              <a:rPr lang="zh-CN" altLang="en-US" dirty="0" smtClean="0"/>
              <a:t>-NGs</a:t>
            </a:r>
            <a:r>
              <a:rPr lang="en-US" altLang="zh-CN" dirty="0" smtClean="0"/>
              <a:t>, PBS, 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34169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5125"/>
            <a:ext cx="3841205" cy="2880000"/>
          </a:xfr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2514" y="365125"/>
            <a:ext cx="3841205" cy="288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9337" y="365125"/>
            <a:ext cx="3840000" cy="2880000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3584464" y="3705321"/>
            <a:ext cx="45783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Source Data-Figure 6e-spleen</a:t>
            </a:r>
            <a:r>
              <a:rPr lang="zh-CN" altLang="en-US" dirty="0" smtClean="0"/>
              <a:t>-NGs</a:t>
            </a:r>
            <a:r>
              <a:rPr lang="en-US" altLang="zh-CN" dirty="0" smtClean="0"/>
              <a:t>, PBS, SCNG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60579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75</Words>
  <Application>Microsoft Office PowerPoint</Application>
  <PresentationFormat>宽屏</PresentationFormat>
  <Paragraphs>8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霞</dc:creator>
  <cp:lastModifiedBy>王 霞</cp:lastModifiedBy>
  <cp:revision>2</cp:revision>
  <dcterms:created xsi:type="dcterms:W3CDTF">2018-11-11T14:07:19Z</dcterms:created>
  <dcterms:modified xsi:type="dcterms:W3CDTF">2018-11-11T14:16:45Z</dcterms:modified>
</cp:coreProperties>
</file>